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8288000" cy="29260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42CEA-BAE7-4359-86A4-73646C3DB2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1645920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914400" y="16914240"/>
            <a:ext cx="1645920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117A4-001E-4C6C-AFD2-1562431667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348480" y="682776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914400" y="1691424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348480" y="1691424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4C7E8-DC91-4CBA-8160-4221F12A0D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52995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479280" y="6827760"/>
            <a:ext cx="52995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2044160" y="6827760"/>
            <a:ext cx="52995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914400" y="16914240"/>
            <a:ext cx="52995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479280" y="16914240"/>
            <a:ext cx="52995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2044160" y="16914240"/>
            <a:ext cx="52995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C28DD-CF15-4096-A1D5-F0B380B48C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914400" y="6827760"/>
            <a:ext cx="16459200" cy="19310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375"/>
              </a:spcBef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71628-3089-4432-95B2-CEF65ED4D2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16459200" cy="193104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7976CF-66E1-4478-8CCB-56256848AA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8031960" cy="193104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348480" y="6827760"/>
            <a:ext cx="8031960" cy="193104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78093B-159B-43F1-9778-2FC4551AA0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2D8ABF-658E-42B9-9492-391B932E10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914400" y="1171080"/>
            <a:ext cx="16459200" cy="2260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375"/>
              </a:spcBef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E194A-C2C8-4D69-B94A-AB343FF9C4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348480" y="6827760"/>
            <a:ext cx="8031960" cy="193104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914400" y="1691424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77C12-390F-45D2-AAF1-733128152A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8031960" cy="193104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348480" y="682776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348480" y="1691424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F8E72-61DA-4F6A-982B-8D890D60EC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914400" y="682776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348480" y="6827760"/>
            <a:ext cx="803196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914400" y="16914240"/>
            <a:ext cx="16459200" cy="921096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indent="0">
              <a:spcBef>
                <a:spcPts val="2375"/>
              </a:spcBef>
              <a:buNone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DD92F-E778-4E8F-BC09-35D9B6F711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14400" y="1171080"/>
            <a:ext cx="16459200" cy="487692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ctr">
            <a:noAutofit/>
          </a:bodyPr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13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14400" y="6827760"/>
            <a:ext cx="16459200" cy="193104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rmAutofit/>
          </a:bodyPr>
          <a:p>
            <a:pPr marL="1019160" indent="-1019160">
              <a:spcBef>
                <a:spcPts val="2375"/>
              </a:spcBef>
              <a:buClr>
                <a:srgbClr val="000000"/>
              </a:buClr>
              <a:buFont typeface="Arial"/>
              <a:buChar char="•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  <a:p>
            <a:pPr lvl="1" marL="2208240" indent="-849240">
              <a:spcBef>
                <a:spcPts val="2375"/>
              </a:spcBef>
              <a:buClr>
                <a:srgbClr val="000000"/>
              </a:buClr>
              <a:buFont typeface="Arial"/>
              <a:buChar char="–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  <a:p>
            <a:pPr lvl="2" marL="3395520" indent="-677880">
              <a:spcBef>
                <a:spcPts val="2375"/>
              </a:spcBef>
              <a:buClr>
                <a:srgbClr val="000000"/>
              </a:buClr>
              <a:buFont typeface="Arial"/>
              <a:buChar char="•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  <a:p>
            <a:pPr lvl="3" marL="4754520" indent="-679320">
              <a:spcBef>
                <a:spcPts val="2375"/>
              </a:spcBef>
              <a:buClr>
                <a:srgbClr val="000000"/>
              </a:buClr>
              <a:buFont typeface="Arial"/>
              <a:buChar char="–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  <a:p>
            <a:pPr lvl="4" marL="6113520" indent="-679680">
              <a:spcBef>
                <a:spcPts val="2375"/>
              </a:spcBef>
              <a:buClr>
                <a:srgbClr val="000000"/>
              </a:buClr>
              <a:buFont typeface="Arial"/>
              <a:buChar char="»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  <a:p>
            <a:pPr lvl="5" marL="6113520" indent="-679680">
              <a:spcBef>
                <a:spcPts val="2375"/>
              </a:spcBef>
              <a:buClr>
                <a:srgbClr val="000000"/>
              </a:buClr>
              <a:buFont typeface="Arial"/>
              <a:buChar char="»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  <a:p>
            <a:pPr lvl="6" marL="6113520" indent="-679680">
              <a:spcBef>
                <a:spcPts val="2375"/>
              </a:spcBef>
              <a:buClr>
                <a:srgbClr val="000000"/>
              </a:buClr>
              <a:buFont typeface="Arial"/>
              <a:buChar char="»"/>
              <a:tabLst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9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9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914040" y="26645760"/>
            <a:ext cx="4267080" cy="20322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Autofit/>
          </a:bodyPr>
          <a:lstStyle>
            <a:lvl1pPr indent="0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  <a:defRPr b="0" lang="en-US" sz="4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248520" y="26645760"/>
            <a:ext cx="5790960" cy="20322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Autofit/>
          </a:bodyPr>
          <a:lstStyle>
            <a:lvl1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  <a:defRPr b="0" lang="en-US" sz="4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3106160" y="26645760"/>
            <a:ext cx="4267080" cy="2032200"/>
          </a:xfrm>
          <a:prstGeom prst="rect">
            <a:avLst/>
          </a:prstGeom>
          <a:noFill/>
          <a:ln w="0">
            <a:noFill/>
          </a:ln>
        </p:spPr>
        <p:txBody>
          <a:bodyPr lIns="271800" rIns="271800" tIns="135720" bIns="135720" anchor="t">
            <a:noAutofit/>
          </a:bodyPr>
          <a:lstStyle>
            <a:lvl1pPr indent="0" algn="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  <a:defRPr b="0" lang="en-US" sz="4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2717640"/>
                <a:tab algn="l" pos="5435640"/>
                <a:tab algn="l" pos="8153280"/>
                <a:tab algn="l" pos="10871280"/>
              </a:tabLst>
            </a:pPr>
            <a:fld id="{2B718E56-A9E0-4AAC-ACFC-B21AEE85AA44}" type="slidenum">
              <a:rPr b="0" lang="en-US" sz="4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746360" y="1555920"/>
            <a:ext cx="5476680" cy="13096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670040" y="960480"/>
            <a:ext cx="281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650960" y="12081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878600" y="13413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1447920" y="3094200"/>
            <a:ext cx="15268320" cy="573372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1552680" y="8885160"/>
            <a:ext cx="15268320" cy="573408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1704960" y="14581080"/>
            <a:ext cx="15268680" cy="573408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5"/>
          <a:stretch/>
        </p:blipFill>
        <p:spPr>
          <a:xfrm>
            <a:off x="1704960" y="20296080"/>
            <a:ext cx="15268680" cy="57340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9" name=""/>
          <p:cNvGraphicFramePr/>
          <p:nvPr/>
        </p:nvGraphicFramePr>
        <p:xfrm>
          <a:off x="8259840" y="1341360"/>
          <a:ext cx="5217840" cy="1647720"/>
        </p:xfrm>
        <a:graphic>
          <a:graphicData uri="http://schemas.openxmlformats.org/drawingml/2006/table">
            <a:tbl>
              <a:tblPr/>
              <a:tblGrid>
                <a:gridCol w="838080"/>
                <a:gridCol w="882720"/>
                <a:gridCol w="879480"/>
                <a:gridCol w="868320"/>
                <a:gridCol w="880920"/>
                <a:gridCol w="868320"/>
              </a:tblGrid>
              <a:tr h="121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us na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88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688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88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88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13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03g046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0" name=""/>
          <p:cNvSpPr/>
          <p:nvPr/>
        </p:nvSpPr>
        <p:spPr>
          <a:xfrm>
            <a:off x="2087640" y="3322800"/>
            <a:ext cx="144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2873520"/>
                <a:tab algn="l" pos="5746680"/>
                <a:tab algn="l" pos="86202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LOC_Os03G046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392200" y="896148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2873520"/>
                <a:tab algn="l" pos="5746680"/>
                <a:tab algn="l" pos="86202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LOC_Os03G046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68520" y="1467648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2873520"/>
                <a:tab algn="l" pos="5746680"/>
                <a:tab algn="l" pos="86202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LOC_Os03G046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468520" y="2046780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2873520"/>
                <a:tab algn="l" pos="5746680"/>
                <a:tab algn="l" pos="86202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LOC_Os03G046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782720" y="25954200"/>
            <a:ext cx="15087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4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hylogenetic analysis, amino acid sequence similarity and expression profiling of tandemly duplicated CYP96 sub-family members. (A) Phylogenetic tree constructed with P450 domain amini acid sequences from tandemly duplicate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CYP96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genes in rice, sorghum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B. distachy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B) Amino acid sequence similarity among 5 tandemly duplicated ric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CYP96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genes. (C) Expression profiling of 5 tandemly duplicated ric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CYP96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genes based on rice microarray analysis. The expression data are retrieved from the website: http://signal.salk.edu/cgi-bin/RiceGE?JOB=APPENDIX&amp;QUERY=GeneAtlas 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706400" y="28656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6T08:06:48Z</dcterms:created>
  <dc:creator>shuye</dc:creator>
  <dc:description/>
  <dc:language>en-US</dc:language>
  <cp:lastModifiedBy>shuye</cp:lastModifiedBy>
  <dcterms:modified xsi:type="dcterms:W3CDTF">2011-08-16T06:19:27Z</dcterms:modified>
  <cp:revision>5</cp:revision>
  <dc:subject/>
  <dc:title>Slide 1</dc:title>
</cp:coreProperties>
</file>